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6FBAE-4C89-491C-8811-B6C8BD2338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B9095-DAE9-4F95-A3CF-2674FF428B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B7067-E6B2-44CC-8E27-FCE67555CC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9FA03-7A87-4E71-82B9-6E1E9B8E80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A2B80-DAB2-488A-831F-0BF36865CC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BD43F-81FE-4606-9664-7F6D9DC2D8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C189B-A190-47B3-A3A8-D2DF12DF21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CFA8A-7FD4-4966-B3E7-141102C2A7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70048-9A23-4B63-AA5A-8F132D03D9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E12D4-9231-4A91-A30B-BF1EFC145C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7E082-B99F-4A5E-8C85-03FD1DA848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C2F37-8A2D-4B42-AD87-B0C8F1A463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D7464F-DC62-4746-ACA7-D026BEFF8B2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199080"/>
            <a:ext cx="6218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6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0" y="4554000"/>
            <a:ext cx="621828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Effect of Antioxidant intervention on menadione toxicity in each FAO disorder under variable conditions.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 Paired t-test compares each FAOD, with and without antioxidants, under each experimental condition, after logarithmic transformation of data. Antioxidants were significantly effective only in the SCADD  and CPT2/MTPD fibroblasts under all 4 conditions, and in the MCADD fibroblasts at 37° with/without glucose. ^ p&lt;0.05 * p&lt;0.005 ** p&lt;0.001 *** p&lt;0.0005 **** p&lt;0.0001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38240" y="762120"/>
          <a:ext cx="5761080" cy="3405240"/>
        </p:xfrm>
        <a:graphic>
          <a:graphicData uri="http://schemas.openxmlformats.org/drawingml/2006/table">
            <a:tbl>
              <a:tblPr/>
              <a:tblGrid>
                <a:gridCol w="1152360"/>
                <a:gridCol w="1150920"/>
                <a:gridCol w="1152720"/>
                <a:gridCol w="1152360"/>
                <a:gridCol w="1152720"/>
              </a:tblGrid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14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Antioxid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9.1 ± 9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9.2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2 ± 7.4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2.0 ± 5.1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0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Antioxid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83.7 ± 30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45.9 ± 25.3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0.8 ± 18.7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2.0 ± 22.5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3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( n=4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2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 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Antioxid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60.3 ± 11.1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1.8 ± 28.3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5.0 ± 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4.5 ± 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3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Antioxida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0.0 ± 9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5.5 ± 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.1 ± 1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5.9 ± 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51:31Z</dcterms:modified>
  <cp:revision>33</cp:revision>
  <dc:subject/>
  <dc:title>Slide 1</dc:title>
</cp:coreProperties>
</file>